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1" y="1122363"/>
            <a:ext cx="10363200" cy="2387600"/>
          </a:xfrm>
        </p:spPr>
        <p:txBody>
          <a:bodyPr anchor="b"/>
          <a:lstStyle>
            <a:lvl1pPr algn="ctr">
              <a:defRPr sz="318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1" y="3602039"/>
            <a:ext cx="9144000" cy="1655762"/>
          </a:xfrm>
        </p:spPr>
        <p:txBody>
          <a:bodyPr/>
          <a:lstStyle>
            <a:lvl1pPr marL="0" indent="0" algn="ctr">
              <a:buNone/>
              <a:defRPr sz="1273"/>
            </a:lvl1pPr>
            <a:lvl2pPr marL="242428" indent="0" algn="ctr">
              <a:buNone/>
              <a:defRPr sz="1060"/>
            </a:lvl2pPr>
            <a:lvl3pPr marL="484856" indent="0" algn="ctr">
              <a:buNone/>
              <a:defRPr sz="954"/>
            </a:lvl3pPr>
            <a:lvl4pPr marL="727285" indent="0" algn="ctr">
              <a:buNone/>
              <a:defRPr sz="849"/>
            </a:lvl4pPr>
            <a:lvl5pPr marL="969713" indent="0" algn="ctr">
              <a:buNone/>
              <a:defRPr sz="849"/>
            </a:lvl5pPr>
            <a:lvl6pPr marL="1212141" indent="0" algn="ctr">
              <a:buNone/>
              <a:defRPr sz="849"/>
            </a:lvl6pPr>
            <a:lvl7pPr marL="1454569" indent="0" algn="ctr">
              <a:buNone/>
              <a:defRPr sz="849"/>
            </a:lvl7pPr>
            <a:lvl8pPr marL="1696998" indent="0" algn="ctr">
              <a:buNone/>
              <a:defRPr sz="849"/>
            </a:lvl8pPr>
            <a:lvl9pPr marL="1939426" indent="0" algn="ctr">
              <a:buNone/>
              <a:defRPr sz="849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590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991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64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374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1" cy="2852737"/>
          </a:xfrm>
        </p:spPr>
        <p:txBody>
          <a:bodyPr anchor="b"/>
          <a:lstStyle>
            <a:lvl1pPr>
              <a:defRPr sz="318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1" cy="1500187"/>
          </a:xfrm>
        </p:spPr>
        <p:txBody>
          <a:bodyPr/>
          <a:lstStyle>
            <a:lvl1pPr marL="0" indent="0">
              <a:buNone/>
              <a:defRPr sz="1273">
                <a:solidFill>
                  <a:schemeClr val="tx1"/>
                </a:solidFill>
              </a:defRPr>
            </a:lvl1pPr>
            <a:lvl2pPr marL="242428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2pPr>
            <a:lvl3pPr marL="484856" indent="0">
              <a:buNone/>
              <a:defRPr sz="954">
                <a:solidFill>
                  <a:schemeClr val="tx1">
                    <a:tint val="75000"/>
                  </a:schemeClr>
                </a:solidFill>
              </a:defRPr>
            </a:lvl3pPr>
            <a:lvl4pPr marL="727285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4pPr>
            <a:lvl5pPr marL="969713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5pPr>
            <a:lvl6pPr marL="1212141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6pPr>
            <a:lvl7pPr marL="1454569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7pPr>
            <a:lvl8pPr marL="1696998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8pPr>
            <a:lvl9pPr marL="1939426" indent="0">
              <a:buNone/>
              <a:defRPr sz="8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877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199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98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7" y="365126"/>
            <a:ext cx="10515601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6" cy="823912"/>
          </a:xfrm>
        </p:spPr>
        <p:txBody>
          <a:bodyPr anchor="b"/>
          <a:lstStyle>
            <a:lvl1pPr marL="0" indent="0">
              <a:buNone/>
              <a:defRPr sz="1273" b="1"/>
            </a:lvl1pPr>
            <a:lvl2pPr marL="242428" indent="0">
              <a:buNone/>
              <a:defRPr sz="1060" b="1"/>
            </a:lvl2pPr>
            <a:lvl3pPr marL="484856" indent="0">
              <a:buNone/>
              <a:defRPr sz="954" b="1"/>
            </a:lvl3pPr>
            <a:lvl4pPr marL="727285" indent="0">
              <a:buNone/>
              <a:defRPr sz="849" b="1"/>
            </a:lvl4pPr>
            <a:lvl5pPr marL="969713" indent="0">
              <a:buNone/>
              <a:defRPr sz="849" b="1"/>
            </a:lvl5pPr>
            <a:lvl6pPr marL="1212141" indent="0">
              <a:buNone/>
              <a:defRPr sz="849" b="1"/>
            </a:lvl6pPr>
            <a:lvl7pPr marL="1454569" indent="0">
              <a:buNone/>
              <a:defRPr sz="849" b="1"/>
            </a:lvl7pPr>
            <a:lvl8pPr marL="1696998" indent="0">
              <a:buNone/>
              <a:defRPr sz="849" b="1"/>
            </a:lvl8pPr>
            <a:lvl9pPr marL="1939426" indent="0">
              <a:buNone/>
              <a:defRPr sz="849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6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9" cy="823912"/>
          </a:xfrm>
        </p:spPr>
        <p:txBody>
          <a:bodyPr anchor="b"/>
          <a:lstStyle>
            <a:lvl1pPr marL="0" indent="0">
              <a:buNone/>
              <a:defRPr sz="1273" b="1"/>
            </a:lvl1pPr>
            <a:lvl2pPr marL="242428" indent="0">
              <a:buNone/>
              <a:defRPr sz="1060" b="1"/>
            </a:lvl2pPr>
            <a:lvl3pPr marL="484856" indent="0">
              <a:buNone/>
              <a:defRPr sz="954" b="1"/>
            </a:lvl3pPr>
            <a:lvl4pPr marL="727285" indent="0">
              <a:buNone/>
              <a:defRPr sz="849" b="1"/>
            </a:lvl4pPr>
            <a:lvl5pPr marL="969713" indent="0">
              <a:buNone/>
              <a:defRPr sz="849" b="1"/>
            </a:lvl5pPr>
            <a:lvl6pPr marL="1212141" indent="0">
              <a:buNone/>
              <a:defRPr sz="849" b="1"/>
            </a:lvl6pPr>
            <a:lvl7pPr marL="1454569" indent="0">
              <a:buNone/>
              <a:defRPr sz="849" b="1"/>
            </a:lvl7pPr>
            <a:lvl8pPr marL="1696998" indent="0">
              <a:buNone/>
              <a:defRPr sz="849" b="1"/>
            </a:lvl8pPr>
            <a:lvl9pPr marL="1939426" indent="0">
              <a:buNone/>
              <a:defRPr sz="849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9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98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97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0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169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90" y="987427"/>
            <a:ext cx="6172199" cy="4873625"/>
          </a:xfrm>
        </p:spPr>
        <p:txBody>
          <a:bodyPr/>
          <a:lstStyle>
            <a:lvl1pPr>
              <a:defRPr sz="1697"/>
            </a:lvl1pPr>
            <a:lvl2pPr>
              <a:defRPr sz="1485"/>
            </a:lvl2pPr>
            <a:lvl3pPr>
              <a:defRPr sz="1273"/>
            </a:lvl3pPr>
            <a:lvl4pPr>
              <a:defRPr sz="1060"/>
            </a:lvl4pPr>
            <a:lvl5pPr>
              <a:defRPr sz="1060"/>
            </a:lvl5pPr>
            <a:lvl6pPr>
              <a:defRPr sz="1060"/>
            </a:lvl6pPr>
            <a:lvl7pPr>
              <a:defRPr sz="1060"/>
            </a:lvl7pPr>
            <a:lvl8pPr>
              <a:defRPr sz="1060"/>
            </a:lvl8pPr>
            <a:lvl9pPr>
              <a:defRPr sz="106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849"/>
            </a:lvl1pPr>
            <a:lvl2pPr marL="242428" indent="0">
              <a:buNone/>
              <a:defRPr sz="742"/>
            </a:lvl2pPr>
            <a:lvl3pPr marL="484856" indent="0">
              <a:buNone/>
              <a:defRPr sz="636"/>
            </a:lvl3pPr>
            <a:lvl4pPr marL="727285" indent="0">
              <a:buNone/>
              <a:defRPr sz="530"/>
            </a:lvl4pPr>
            <a:lvl5pPr marL="969713" indent="0">
              <a:buNone/>
              <a:defRPr sz="530"/>
            </a:lvl5pPr>
            <a:lvl6pPr marL="1212141" indent="0">
              <a:buNone/>
              <a:defRPr sz="530"/>
            </a:lvl6pPr>
            <a:lvl7pPr marL="1454569" indent="0">
              <a:buNone/>
              <a:defRPr sz="530"/>
            </a:lvl7pPr>
            <a:lvl8pPr marL="1696998" indent="0">
              <a:buNone/>
              <a:defRPr sz="530"/>
            </a:lvl8pPr>
            <a:lvl9pPr marL="1939426" indent="0">
              <a:buNone/>
              <a:defRPr sz="53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83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169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90" y="987427"/>
            <a:ext cx="6172199" cy="4873625"/>
          </a:xfrm>
        </p:spPr>
        <p:txBody>
          <a:bodyPr anchor="t"/>
          <a:lstStyle>
            <a:lvl1pPr marL="0" indent="0">
              <a:buNone/>
              <a:defRPr sz="1697"/>
            </a:lvl1pPr>
            <a:lvl2pPr marL="242428" indent="0">
              <a:buNone/>
              <a:defRPr sz="1485"/>
            </a:lvl2pPr>
            <a:lvl3pPr marL="484856" indent="0">
              <a:buNone/>
              <a:defRPr sz="1273"/>
            </a:lvl3pPr>
            <a:lvl4pPr marL="727285" indent="0">
              <a:buNone/>
              <a:defRPr sz="1060"/>
            </a:lvl4pPr>
            <a:lvl5pPr marL="969713" indent="0">
              <a:buNone/>
              <a:defRPr sz="1060"/>
            </a:lvl5pPr>
            <a:lvl6pPr marL="1212141" indent="0">
              <a:buNone/>
              <a:defRPr sz="1060"/>
            </a:lvl6pPr>
            <a:lvl7pPr marL="1454569" indent="0">
              <a:buNone/>
              <a:defRPr sz="1060"/>
            </a:lvl7pPr>
            <a:lvl8pPr marL="1696998" indent="0">
              <a:buNone/>
              <a:defRPr sz="1060"/>
            </a:lvl8pPr>
            <a:lvl9pPr marL="1939426" indent="0">
              <a:buNone/>
              <a:defRPr sz="106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849"/>
            </a:lvl1pPr>
            <a:lvl2pPr marL="242428" indent="0">
              <a:buNone/>
              <a:defRPr sz="742"/>
            </a:lvl2pPr>
            <a:lvl3pPr marL="484856" indent="0">
              <a:buNone/>
              <a:defRPr sz="636"/>
            </a:lvl3pPr>
            <a:lvl4pPr marL="727285" indent="0">
              <a:buNone/>
              <a:defRPr sz="530"/>
            </a:lvl4pPr>
            <a:lvl5pPr marL="969713" indent="0">
              <a:buNone/>
              <a:defRPr sz="530"/>
            </a:lvl5pPr>
            <a:lvl6pPr marL="1212141" indent="0">
              <a:buNone/>
              <a:defRPr sz="530"/>
            </a:lvl6pPr>
            <a:lvl7pPr marL="1454569" indent="0">
              <a:buNone/>
              <a:defRPr sz="530"/>
            </a:lvl7pPr>
            <a:lvl8pPr marL="1696998" indent="0">
              <a:buNone/>
              <a:defRPr sz="530"/>
            </a:lvl8pPr>
            <a:lvl9pPr marL="1939426" indent="0">
              <a:buNone/>
              <a:defRPr sz="53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777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FED36-A600-4322-AF99-6414A9348927}" type="datetimeFigureOut">
              <a:rPr lang="en-US" smtClean="0"/>
              <a:t>9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1"/>
            <a:ext cx="411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5DB17-538B-4E75-B1D5-ED8E1955E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042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84856" rtl="0" eaLnBrk="1" latinLnBrk="0" hangingPunct="1">
        <a:lnSpc>
          <a:spcPct val="90000"/>
        </a:lnSpc>
        <a:spcBef>
          <a:spcPct val="0"/>
        </a:spcBef>
        <a:buNone/>
        <a:defRPr sz="23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214" indent="-121214" algn="l" defTabSz="484856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63642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1273" kern="1200">
          <a:solidFill>
            <a:schemeClr val="tx1"/>
          </a:solidFill>
          <a:latin typeface="+mn-lt"/>
          <a:ea typeface="+mn-ea"/>
          <a:cs typeface="+mn-cs"/>
        </a:defRPr>
      </a:lvl2pPr>
      <a:lvl3pPr marL="606070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1060" kern="1200">
          <a:solidFill>
            <a:schemeClr val="tx1"/>
          </a:solidFill>
          <a:latin typeface="+mn-lt"/>
          <a:ea typeface="+mn-ea"/>
          <a:cs typeface="+mn-cs"/>
        </a:defRPr>
      </a:lvl3pPr>
      <a:lvl4pPr marL="848498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4pPr>
      <a:lvl5pPr marL="1090927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5pPr>
      <a:lvl6pPr marL="1333355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6pPr>
      <a:lvl7pPr marL="1575783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7pPr>
      <a:lvl8pPr marL="1818211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8pPr>
      <a:lvl9pPr marL="2060640" indent="-121214" algn="l" defTabSz="484856" rtl="0" eaLnBrk="1" latinLnBrk="0" hangingPunct="1">
        <a:lnSpc>
          <a:spcPct val="90000"/>
        </a:lnSpc>
        <a:spcBef>
          <a:spcPts val="265"/>
        </a:spcBef>
        <a:buFont typeface="Arial" panose="020B0604020202020204" pitchFamily="34" charset="0"/>
        <a:buChar char="•"/>
        <a:defRPr sz="9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1pPr>
      <a:lvl2pPr marL="242428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2pPr>
      <a:lvl3pPr marL="484856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3pPr>
      <a:lvl4pPr marL="727285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4pPr>
      <a:lvl5pPr marL="969713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5pPr>
      <a:lvl6pPr marL="1212141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6pPr>
      <a:lvl7pPr marL="1454569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7pPr>
      <a:lvl8pPr marL="1696998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8pPr>
      <a:lvl9pPr marL="1939426" algn="l" defTabSz="484856" rtl="0" eaLnBrk="1" latinLnBrk="0" hangingPunct="1">
        <a:defRPr sz="9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6B3A3C39-3337-493A-8CF6-0F2B0F52606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87" t="4829" r="10159"/>
          <a:stretch/>
        </p:blipFill>
        <p:spPr bwMode="auto">
          <a:xfrm>
            <a:off x="630490" y="784840"/>
            <a:ext cx="3671544" cy="5271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>
            <a:extLst>
              <a:ext uri="{FF2B5EF4-FFF2-40B4-BE49-F238E27FC236}">
                <a16:creationId xmlns:a16="http://schemas.microsoft.com/office/drawing/2014/main" id="{3F4AD718-02E8-46A8-A40C-71689BAE31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5" r="8685"/>
          <a:stretch/>
        </p:blipFill>
        <p:spPr bwMode="auto">
          <a:xfrm>
            <a:off x="4426143" y="725587"/>
            <a:ext cx="3733788" cy="52711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EA0F48E2-B59A-4AD9-B505-79EB6435FBE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0" r="7252" b="1642"/>
          <a:stretch/>
        </p:blipFill>
        <p:spPr bwMode="auto">
          <a:xfrm>
            <a:off x="8284040" y="784838"/>
            <a:ext cx="3646703" cy="5145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9C68A6E-06FA-4794-933D-3DB61331E8BC}"/>
              </a:ext>
            </a:extLst>
          </p:cNvPr>
          <p:cNvCxnSpPr>
            <a:cxnSpLocks/>
          </p:cNvCxnSpPr>
          <p:nvPr/>
        </p:nvCxnSpPr>
        <p:spPr>
          <a:xfrm>
            <a:off x="10737744" y="793547"/>
            <a:ext cx="0" cy="5145699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52932A9-08C2-4777-8312-11548C2C02BE}"/>
              </a:ext>
            </a:extLst>
          </p:cNvPr>
          <p:cNvCxnSpPr>
            <a:cxnSpLocks/>
          </p:cNvCxnSpPr>
          <p:nvPr/>
        </p:nvCxnSpPr>
        <p:spPr>
          <a:xfrm>
            <a:off x="1837509" y="784838"/>
            <a:ext cx="60960" cy="5145699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A902B92-9F33-4129-8165-93747B93DDEC}"/>
              </a:ext>
            </a:extLst>
          </p:cNvPr>
          <p:cNvCxnSpPr>
            <a:cxnSpLocks/>
          </p:cNvCxnSpPr>
          <p:nvPr/>
        </p:nvCxnSpPr>
        <p:spPr>
          <a:xfrm>
            <a:off x="3091557" y="784838"/>
            <a:ext cx="0" cy="5145699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CA547E2-79C5-4587-9DC2-CE694AA2152B}"/>
              </a:ext>
            </a:extLst>
          </p:cNvPr>
          <p:cNvCxnSpPr>
            <a:cxnSpLocks/>
          </p:cNvCxnSpPr>
          <p:nvPr/>
        </p:nvCxnSpPr>
        <p:spPr>
          <a:xfrm>
            <a:off x="6932069" y="793547"/>
            <a:ext cx="0" cy="5145699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E8FD7DC-CFAB-4827-8395-FE2513388957}"/>
              </a:ext>
            </a:extLst>
          </p:cNvPr>
          <p:cNvCxnSpPr>
            <a:cxnSpLocks/>
          </p:cNvCxnSpPr>
          <p:nvPr/>
        </p:nvCxnSpPr>
        <p:spPr>
          <a:xfrm>
            <a:off x="9492406" y="793547"/>
            <a:ext cx="0" cy="5145699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41F3BCB2-9C96-4C28-A756-C858C64EBC54}"/>
              </a:ext>
            </a:extLst>
          </p:cNvPr>
          <p:cNvSpPr txBox="1"/>
          <p:nvPr/>
        </p:nvSpPr>
        <p:spPr>
          <a:xfrm>
            <a:off x="592172" y="571698"/>
            <a:ext cx="11408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 </a:t>
            </a:r>
            <a:r>
              <a:rPr kumimoji="0" lang="en-GB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dorsal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5E1950-CDEA-4071-B6BF-D11F4CBCE594}"/>
              </a:ext>
            </a:extLst>
          </p:cNvPr>
          <p:cNvSpPr txBox="1"/>
          <p:nvPr/>
        </p:nvSpPr>
        <p:spPr>
          <a:xfrm>
            <a:off x="1837509" y="351627"/>
            <a:ext cx="9118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non-treated                                                       30 mg kg</a:t>
            </a:r>
            <a:r>
              <a:rPr kumimoji="0" lang="en-GB" sz="14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Z                                                    100 mg kg</a:t>
            </a:r>
            <a:r>
              <a:rPr kumimoji="0" lang="en-GB" sz="14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</a:t>
            </a: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Z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B3B5BB-DD09-433B-9835-09DFBB57CE73}"/>
              </a:ext>
            </a:extLst>
          </p:cNvPr>
          <p:cNvSpPr txBox="1"/>
          <p:nvPr/>
        </p:nvSpPr>
        <p:spPr>
          <a:xfrm>
            <a:off x="232251" y="917139"/>
            <a:ext cx="420308" cy="51319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1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3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1</a:t>
            </a:r>
          </a:p>
          <a:p>
            <a:pPr marL="0" marR="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38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82</a:t>
            </a: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20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9</a:t>
            </a: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17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00</a:t>
            </a:r>
          </a:p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AB834F3-1E33-4971-97F1-6A383F133843}"/>
              </a:ext>
            </a:extLst>
          </p:cNvPr>
          <p:cNvCxnSpPr>
            <a:cxnSpLocks/>
          </p:cNvCxnSpPr>
          <p:nvPr/>
        </p:nvCxnSpPr>
        <p:spPr>
          <a:xfrm>
            <a:off x="8265250" y="3143793"/>
            <a:ext cx="367420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387C098-6EC2-4739-B26B-515A26049D8F}"/>
              </a:ext>
            </a:extLst>
          </p:cNvPr>
          <p:cNvCxnSpPr/>
          <p:nvPr/>
        </p:nvCxnSpPr>
        <p:spPr>
          <a:xfrm>
            <a:off x="635141" y="3169920"/>
            <a:ext cx="3649475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4A149F6-D50B-4559-9394-7A1B31B62D31}"/>
              </a:ext>
            </a:extLst>
          </p:cNvPr>
          <p:cNvCxnSpPr>
            <a:cxnSpLocks/>
          </p:cNvCxnSpPr>
          <p:nvPr/>
        </p:nvCxnSpPr>
        <p:spPr>
          <a:xfrm>
            <a:off x="4433463" y="3196047"/>
            <a:ext cx="3717759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02E102E-C890-4AA7-BAC8-53E6A076F0D5}"/>
              </a:ext>
            </a:extLst>
          </p:cNvPr>
          <p:cNvCxnSpPr/>
          <p:nvPr/>
        </p:nvCxnSpPr>
        <p:spPr>
          <a:xfrm>
            <a:off x="11742698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47D110D-D070-472A-B57F-FB5CB04F5983}"/>
              </a:ext>
            </a:extLst>
          </p:cNvPr>
          <p:cNvCxnSpPr/>
          <p:nvPr/>
        </p:nvCxnSpPr>
        <p:spPr>
          <a:xfrm>
            <a:off x="630490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7FF82F3-EB11-4AB8-B368-7FA1A0CD8292}"/>
              </a:ext>
            </a:extLst>
          </p:cNvPr>
          <p:cNvCxnSpPr/>
          <p:nvPr/>
        </p:nvCxnSpPr>
        <p:spPr>
          <a:xfrm>
            <a:off x="4279396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B62E8394-DEAC-448E-AA84-7F05E40981E0}"/>
              </a:ext>
            </a:extLst>
          </p:cNvPr>
          <p:cNvCxnSpPr/>
          <p:nvPr/>
        </p:nvCxnSpPr>
        <p:spPr>
          <a:xfrm>
            <a:off x="4444867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1C3E610-9F7D-45C9-A9F2-1C0BDDE400CC}"/>
              </a:ext>
            </a:extLst>
          </p:cNvPr>
          <p:cNvCxnSpPr/>
          <p:nvPr/>
        </p:nvCxnSpPr>
        <p:spPr>
          <a:xfrm>
            <a:off x="8076363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F43E832-8B92-44E7-9DD6-0157D5A40AC5}"/>
              </a:ext>
            </a:extLst>
          </p:cNvPr>
          <p:cNvCxnSpPr/>
          <p:nvPr/>
        </p:nvCxnSpPr>
        <p:spPr>
          <a:xfrm>
            <a:off x="8250543" y="374475"/>
            <a:ext cx="0" cy="26167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48ED3D2-5A4A-4B9D-BA78-7C048F1BEF85}"/>
              </a:ext>
            </a:extLst>
          </p:cNvPr>
          <p:cNvCxnSpPr>
            <a:cxnSpLocks/>
          </p:cNvCxnSpPr>
          <p:nvPr/>
        </p:nvCxnSpPr>
        <p:spPr>
          <a:xfrm>
            <a:off x="10719722" y="505312"/>
            <a:ext cx="10183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9924383A-D743-496B-85EE-5BE84792F734}"/>
              </a:ext>
            </a:extLst>
          </p:cNvPr>
          <p:cNvCxnSpPr>
            <a:cxnSpLocks/>
          </p:cNvCxnSpPr>
          <p:nvPr/>
        </p:nvCxnSpPr>
        <p:spPr>
          <a:xfrm>
            <a:off x="643850" y="505312"/>
            <a:ext cx="1184950" cy="2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D961AF97-72E5-4C1A-88DF-AAC9B7B5E4B0}"/>
              </a:ext>
            </a:extLst>
          </p:cNvPr>
          <p:cNvCxnSpPr>
            <a:cxnSpLocks/>
          </p:cNvCxnSpPr>
          <p:nvPr/>
        </p:nvCxnSpPr>
        <p:spPr>
          <a:xfrm>
            <a:off x="3099683" y="505312"/>
            <a:ext cx="1184950" cy="2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F11955C-2B99-4F5A-A815-6FC9AC215261}"/>
              </a:ext>
            </a:extLst>
          </p:cNvPr>
          <p:cNvCxnSpPr>
            <a:cxnSpLocks/>
          </p:cNvCxnSpPr>
          <p:nvPr/>
        </p:nvCxnSpPr>
        <p:spPr>
          <a:xfrm>
            <a:off x="4423386" y="505312"/>
            <a:ext cx="1184950" cy="2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0D7B07B-5A5A-45D6-B00C-12445BD3FC2E}"/>
              </a:ext>
            </a:extLst>
          </p:cNvPr>
          <p:cNvCxnSpPr>
            <a:cxnSpLocks/>
          </p:cNvCxnSpPr>
          <p:nvPr/>
        </p:nvCxnSpPr>
        <p:spPr>
          <a:xfrm>
            <a:off x="6896637" y="505312"/>
            <a:ext cx="1184950" cy="2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47E9E7A-1ECA-46DE-95B7-9DC5F5808741}"/>
              </a:ext>
            </a:extLst>
          </p:cNvPr>
          <p:cNvCxnSpPr>
            <a:cxnSpLocks/>
          </p:cNvCxnSpPr>
          <p:nvPr/>
        </p:nvCxnSpPr>
        <p:spPr>
          <a:xfrm>
            <a:off x="8237762" y="505312"/>
            <a:ext cx="10183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CEDE404-7286-43F3-8DE3-AFDE1037D939}"/>
              </a:ext>
            </a:extLst>
          </p:cNvPr>
          <p:cNvSpPr txBox="1"/>
          <p:nvPr/>
        </p:nvSpPr>
        <p:spPr>
          <a:xfrm>
            <a:off x="190936" y="609362"/>
            <a:ext cx="4523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pi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885C7A9-AE09-44FF-8218-75811A850A69}"/>
              </a:ext>
            </a:extLst>
          </p:cNvPr>
          <p:cNvCxnSpPr/>
          <p:nvPr/>
        </p:nvCxnSpPr>
        <p:spPr>
          <a:xfrm>
            <a:off x="232251" y="3169920"/>
            <a:ext cx="35992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Picture 40">
            <a:extLst>
              <a:ext uri="{FF2B5EF4-FFF2-40B4-BE49-F238E27FC236}">
                <a16:creationId xmlns:a16="http://schemas.microsoft.com/office/drawing/2014/main" id="{D7447BC4-6E19-49E8-9790-CE22FBB65A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79396" y="5965384"/>
            <a:ext cx="3818395" cy="5238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847B7FB-E572-4129-8057-4F629AFE16E3}"/>
              </a:ext>
            </a:extLst>
          </p:cNvPr>
          <p:cNvSpPr txBox="1"/>
          <p:nvPr/>
        </p:nvSpPr>
        <p:spPr>
          <a:xfrm>
            <a:off x="62333" y="6473971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 Fig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003753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41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elly</dc:creator>
  <cp:lastModifiedBy>John Kelly</cp:lastModifiedBy>
  <cp:revision>4</cp:revision>
  <dcterms:created xsi:type="dcterms:W3CDTF">2022-05-16T12:30:38Z</dcterms:created>
  <dcterms:modified xsi:type="dcterms:W3CDTF">2022-09-21T13:43:37Z</dcterms:modified>
</cp:coreProperties>
</file>